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6" r:id="rId2"/>
    <p:sldId id="290" r:id="rId3"/>
    <p:sldId id="291" r:id="rId4"/>
    <p:sldId id="292" r:id="rId5"/>
    <p:sldId id="294" r:id="rId6"/>
    <p:sldId id="293" r:id="rId7"/>
  </p:sldIdLst>
  <p:sldSz cx="12192000" cy="6858000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therine Adans Dester" initials="CAD" lastIdx="3" clrIdx="0">
    <p:extLst>
      <p:ext uri="{19B8F6BF-5375-455C-9EA6-DF929625EA0E}">
        <p15:presenceInfo xmlns:p15="http://schemas.microsoft.com/office/powerpoint/2012/main" userId="S::cadans-dester@partners.org::fd70098f-3cbb-4023-9868-ffa1f0bcae0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33"/>
    <a:srgbClr val="33CC33"/>
    <a:srgbClr val="548235"/>
    <a:srgbClr val="009600"/>
    <a:srgbClr val="FF5050"/>
    <a:srgbClr val="FF3300"/>
    <a:srgbClr val="DAE3F3"/>
    <a:srgbClr val="8FAADC"/>
    <a:srgbClr val="4472C4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5664" autoAdjust="0"/>
  </p:normalViewPr>
  <p:slideViewPr>
    <p:cSldViewPr snapToGrid="0">
      <p:cViewPr varScale="1">
        <p:scale>
          <a:sx n="75" d="100"/>
          <a:sy n="75" d="100"/>
        </p:scale>
        <p:origin x="723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98B73EE2-4EA9-463B-A7DF-A78888ECDB3A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540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D2E146F3-6F51-47B5-B369-6D9D32AF3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4843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320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073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655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761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233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189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7905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459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288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827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465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75B48-CB0A-4599-A0F4-135B2450A045}" type="datetimeFigureOut">
              <a:rPr lang="en-US" smtClean="0"/>
              <a:t>5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02705C-247C-43A3-92AF-8CF6089A08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326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9.png"/><Relationship Id="rId7" Type="http://schemas.openxmlformats.org/officeDocument/2006/relationships/image" Target="../media/image7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5.png"/><Relationship Id="rId7" Type="http://schemas.openxmlformats.org/officeDocument/2006/relationships/image" Target="../media/image7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11" Type="http://schemas.openxmlformats.org/officeDocument/2006/relationships/image" Target="../media/image28.png"/><Relationship Id="rId5" Type="http://schemas.openxmlformats.org/officeDocument/2006/relationships/image" Target="../media/image23.png"/><Relationship Id="rId10" Type="http://schemas.openxmlformats.org/officeDocument/2006/relationships/image" Target="../media/image27.png"/><Relationship Id="rId4" Type="http://schemas.openxmlformats.org/officeDocument/2006/relationships/image" Target="../media/image22.png"/><Relationship Id="rId9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30.png"/><Relationship Id="rId7" Type="http://schemas.openxmlformats.org/officeDocument/2006/relationships/image" Target="../media/image7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EA16C2-CD77-494E-9441-1337EF408EF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Material</a:t>
            </a:r>
          </a:p>
        </p:txBody>
      </p:sp>
    </p:spTree>
    <p:extLst>
      <p:ext uri="{BB962C8B-B14F-4D97-AF65-F5344CB8AC3E}">
        <p14:creationId xmlns:p14="http://schemas.microsoft.com/office/powerpoint/2010/main" val="32236821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132E03DD-AC54-4A89-A65A-6D1FF792DB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7071" y="3791004"/>
            <a:ext cx="3658994" cy="27432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EAD09F8-76B4-4F5D-B893-883FDAEA97E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7071" y="1056164"/>
            <a:ext cx="3658994" cy="27432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ED21CDA-43A4-4A41-AE2E-4A9B53F5B2A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7029" y="1056164"/>
            <a:ext cx="3658994" cy="27432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E455809-E83A-4E08-A5E1-AF3CF947728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7029" y="3796996"/>
            <a:ext cx="3658994" cy="27432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7C4F071-33DC-476D-ABA8-9C9E5DF13C8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92" y="3799364"/>
            <a:ext cx="3658994" cy="27432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3011C93-AFDB-478F-ACDD-38D21655E0E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92" y="1058532"/>
            <a:ext cx="3658994" cy="27432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BF481F8-BECD-40FB-9128-48DB4FA8CCD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5703" t="47433" r="50000"/>
          <a:stretch/>
        </p:blipFill>
        <p:spPr>
          <a:xfrm>
            <a:off x="7691280" y="3421412"/>
            <a:ext cx="523876" cy="312115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BE69164-3D02-4FA6-B16C-3DC24021D64C}"/>
              </a:ext>
            </a:extLst>
          </p:cNvPr>
          <p:cNvSpPr/>
          <p:nvPr/>
        </p:nvSpPr>
        <p:spPr>
          <a:xfrm>
            <a:off x="491318" y="445273"/>
            <a:ext cx="10957731" cy="5946002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FBF3ADB-D4DE-48CD-B37B-F77F793F0D32}"/>
              </a:ext>
            </a:extLst>
          </p:cNvPr>
          <p:cNvSpPr txBox="1"/>
          <p:nvPr/>
        </p:nvSpPr>
        <p:spPr>
          <a:xfrm>
            <a:off x="4526280" y="242471"/>
            <a:ext cx="3089743" cy="40011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fficiency &amp; Accuracy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299BDF-6538-40A0-876A-1073493101D4}"/>
              </a:ext>
            </a:extLst>
          </p:cNvPr>
          <p:cNvSpPr txBox="1"/>
          <p:nvPr/>
        </p:nvSpPr>
        <p:spPr>
          <a:xfrm>
            <a:off x="1328050" y="676106"/>
            <a:ext cx="1945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on-pareti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F79CD95-07BD-4C8F-BB84-612BAC4B8A06}"/>
              </a:ext>
            </a:extLst>
          </p:cNvPr>
          <p:cNvSpPr txBox="1"/>
          <p:nvPr/>
        </p:nvSpPr>
        <p:spPr>
          <a:xfrm>
            <a:off x="8580467" y="676106"/>
            <a:ext cx="23940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ost- Paretic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1457EF6-E148-46D7-BD01-5E98F265A30B}"/>
              </a:ext>
            </a:extLst>
          </p:cNvPr>
          <p:cNvSpPr/>
          <p:nvPr/>
        </p:nvSpPr>
        <p:spPr>
          <a:xfrm>
            <a:off x="423092" y="6451459"/>
            <a:ext cx="1155845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A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riance observed across targets in the kinematic variables of efficiency in the non-paretic and paretic arm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314CC51-603E-4D3C-8D64-37096D8D39C8}"/>
              </a:ext>
            </a:extLst>
          </p:cNvPr>
          <p:cNvSpPr txBox="1"/>
          <p:nvPr/>
        </p:nvSpPr>
        <p:spPr>
          <a:xfrm>
            <a:off x="4719131" y="676106"/>
            <a:ext cx="22621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e- Paretic</a:t>
            </a:r>
          </a:p>
        </p:txBody>
      </p:sp>
    </p:spTree>
    <p:extLst>
      <p:ext uri="{BB962C8B-B14F-4D97-AF65-F5344CB8AC3E}">
        <p14:creationId xmlns:p14="http://schemas.microsoft.com/office/powerpoint/2010/main" val="18731926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0604042A-CB97-4302-B433-1A1C0EB65A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7542" y="3741888"/>
            <a:ext cx="3658994" cy="27432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9153DB39-1391-4D1F-866A-0FC571ACE0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1217" y="992784"/>
            <a:ext cx="3658994" cy="27432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11F6A0D8-2BE4-4456-83B0-10F43E4C6A2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9963" y="3766076"/>
            <a:ext cx="3658994" cy="27432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AFF9EA7-C0F7-49A9-9BAD-D1BB01EB296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328" y="3766076"/>
            <a:ext cx="3658994" cy="27432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0AF5AE0-6C81-40D3-9528-37775C3FE22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328" y="992785"/>
            <a:ext cx="3658994" cy="27432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BF481F8-BECD-40FB-9128-48DB4FA8CCD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5703" t="47433" r="50000"/>
          <a:stretch/>
        </p:blipFill>
        <p:spPr>
          <a:xfrm>
            <a:off x="7691280" y="3421412"/>
            <a:ext cx="523876" cy="312115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BE69164-3D02-4FA6-B16C-3DC24021D64C}"/>
              </a:ext>
            </a:extLst>
          </p:cNvPr>
          <p:cNvSpPr/>
          <p:nvPr/>
        </p:nvSpPr>
        <p:spPr>
          <a:xfrm>
            <a:off x="491318" y="445273"/>
            <a:ext cx="10957731" cy="5946002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FBF3ADB-D4DE-48CD-B37B-F77F793F0D32}"/>
              </a:ext>
            </a:extLst>
          </p:cNvPr>
          <p:cNvSpPr txBox="1"/>
          <p:nvPr/>
        </p:nvSpPr>
        <p:spPr>
          <a:xfrm>
            <a:off x="4563043" y="242471"/>
            <a:ext cx="3065914" cy="40011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peed and Planning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7925E18-8C42-49E5-AAC0-93D13BABFAE6}"/>
              </a:ext>
            </a:extLst>
          </p:cNvPr>
          <p:cNvSpPr/>
          <p:nvPr/>
        </p:nvSpPr>
        <p:spPr>
          <a:xfrm>
            <a:off x="423092" y="6451459"/>
            <a:ext cx="1212450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B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riance observed across targets in the kinematic variables of speed and planning in the non-paretic and paretic arm.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EE2C449-A7CE-46FA-93A7-A871B4D7135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9963" y="992784"/>
            <a:ext cx="3658994" cy="27432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CF4670A-2D46-4504-9336-8ECAE38ADF4E}"/>
              </a:ext>
            </a:extLst>
          </p:cNvPr>
          <p:cNvSpPr txBox="1"/>
          <p:nvPr/>
        </p:nvSpPr>
        <p:spPr>
          <a:xfrm>
            <a:off x="1328050" y="702765"/>
            <a:ext cx="1945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on-pareti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0B44C1E-50BF-469F-993A-5BE63C99A319}"/>
              </a:ext>
            </a:extLst>
          </p:cNvPr>
          <p:cNvSpPr txBox="1"/>
          <p:nvPr/>
        </p:nvSpPr>
        <p:spPr>
          <a:xfrm>
            <a:off x="4734548" y="702765"/>
            <a:ext cx="22621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e- Pareti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18E97A0-4593-49C8-8785-D57D04C864CF}"/>
              </a:ext>
            </a:extLst>
          </p:cNvPr>
          <p:cNvSpPr txBox="1"/>
          <p:nvPr/>
        </p:nvSpPr>
        <p:spPr>
          <a:xfrm>
            <a:off x="8502423" y="702765"/>
            <a:ext cx="23940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ost- Paretic</a:t>
            </a:r>
          </a:p>
        </p:txBody>
      </p:sp>
    </p:spTree>
    <p:extLst>
      <p:ext uri="{BB962C8B-B14F-4D97-AF65-F5344CB8AC3E}">
        <p14:creationId xmlns:p14="http://schemas.microsoft.com/office/powerpoint/2010/main" val="2203146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562A6E84-1C22-4FC6-A0B3-C6D501D39B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0055" y="996571"/>
            <a:ext cx="3658994" cy="27432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CE14078-2361-4B0A-ADE1-F8BD3628396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2086" y="3739771"/>
            <a:ext cx="3658994" cy="27432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ADDA3B45-A8B4-4D80-8ADC-5CCB8A2D73E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92" y="3739771"/>
            <a:ext cx="3658994" cy="27432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938523C6-1823-406B-8BCF-C3CD69016D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0055" y="3739771"/>
            <a:ext cx="3658994" cy="27432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7383A18-F398-478C-9331-7839F5493C5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92" y="996571"/>
            <a:ext cx="3658994" cy="27432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BF481F8-BECD-40FB-9128-48DB4FA8CCD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5703" t="47433" r="50000"/>
          <a:stretch/>
        </p:blipFill>
        <p:spPr>
          <a:xfrm>
            <a:off x="7691280" y="3421412"/>
            <a:ext cx="523876" cy="312115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BE69164-3D02-4FA6-B16C-3DC24021D64C}"/>
              </a:ext>
            </a:extLst>
          </p:cNvPr>
          <p:cNvSpPr/>
          <p:nvPr/>
        </p:nvSpPr>
        <p:spPr>
          <a:xfrm>
            <a:off x="491318" y="445273"/>
            <a:ext cx="10957731" cy="5946002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FBF3ADB-D4DE-48CD-B37B-F77F793F0D32}"/>
              </a:ext>
            </a:extLst>
          </p:cNvPr>
          <p:cNvSpPr txBox="1"/>
          <p:nvPr/>
        </p:nvSpPr>
        <p:spPr>
          <a:xfrm>
            <a:off x="4924709" y="242471"/>
            <a:ext cx="2342582" cy="40011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moothness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438D456-B9C6-402F-83E0-A966699BD0F3}"/>
              </a:ext>
            </a:extLst>
          </p:cNvPr>
          <p:cNvSpPr/>
          <p:nvPr/>
        </p:nvSpPr>
        <p:spPr>
          <a:xfrm>
            <a:off x="423092" y="6451459"/>
            <a:ext cx="1134028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C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riance observed across targets in the kinematic variables of smoothness in the non-paretic and paretic arm.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E436ECFA-2E52-4080-8EAD-9E64942CDD5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2889" y="996571"/>
            <a:ext cx="3658994" cy="27432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86C3CC0-1BF0-42A1-B68C-B5296324B609}"/>
              </a:ext>
            </a:extLst>
          </p:cNvPr>
          <p:cNvSpPr txBox="1"/>
          <p:nvPr/>
        </p:nvSpPr>
        <p:spPr>
          <a:xfrm>
            <a:off x="1328050" y="690593"/>
            <a:ext cx="1945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on-pareti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5D1A8C7-6E0D-4053-99FB-C7808F9E23AF}"/>
              </a:ext>
            </a:extLst>
          </p:cNvPr>
          <p:cNvSpPr txBox="1"/>
          <p:nvPr/>
        </p:nvSpPr>
        <p:spPr>
          <a:xfrm>
            <a:off x="4775393" y="690593"/>
            <a:ext cx="22621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e- Pareti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01F6503-F421-4152-8D8B-E9E28C07B89F}"/>
              </a:ext>
            </a:extLst>
          </p:cNvPr>
          <p:cNvSpPr txBox="1"/>
          <p:nvPr/>
        </p:nvSpPr>
        <p:spPr>
          <a:xfrm>
            <a:off x="8469868" y="690593"/>
            <a:ext cx="23940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ost- Paretic</a:t>
            </a:r>
          </a:p>
        </p:txBody>
      </p:sp>
    </p:spTree>
    <p:extLst>
      <p:ext uri="{BB962C8B-B14F-4D97-AF65-F5344CB8AC3E}">
        <p14:creationId xmlns:p14="http://schemas.microsoft.com/office/powerpoint/2010/main" val="32570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95CCDAB4-F797-4C3B-889D-5D613854BE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1072" y="4637231"/>
            <a:ext cx="2439329" cy="18288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134BB153-0902-4631-91A5-CA3231A84BC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823" y="2808431"/>
            <a:ext cx="2439329" cy="18288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C6F44798-8A00-4349-8B3E-EA0F0DBEF03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823" y="4652063"/>
            <a:ext cx="2439329" cy="18288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80B795A6-3F96-4F04-98F4-2DB8F4B7468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6823" y="964799"/>
            <a:ext cx="2439330" cy="18288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B947F9B9-9548-4B2A-9737-7D05991FE44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72" y="2824191"/>
            <a:ext cx="2439331" cy="18288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529A75DF-0FB3-4401-B79B-57D0F0DA702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72" y="968758"/>
            <a:ext cx="2439331" cy="18288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FC90F77-03AA-4AC3-833A-5D577F61024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73" y="4652063"/>
            <a:ext cx="2439329" cy="1828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BF481F8-BECD-40FB-9128-48DB4FA8CCD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5703" t="47433" r="50000"/>
          <a:stretch/>
        </p:blipFill>
        <p:spPr>
          <a:xfrm>
            <a:off x="7691280" y="3421412"/>
            <a:ext cx="523876" cy="312115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BE69164-3D02-4FA6-B16C-3DC24021D64C}"/>
              </a:ext>
            </a:extLst>
          </p:cNvPr>
          <p:cNvSpPr/>
          <p:nvPr/>
        </p:nvSpPr>
        <p:spPr>
          <a:xfrm>
            <a:off x="491318" y="445273"/>
            <a:ext cx="10957731" cy="5946002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FBF3ADB-D4DE-48CD-B37B-F77F793F0D32}"/>
              </a:ext>
            </a:extLst>
          </p:cNvPr>
          <p:cNvSpPr txBox="1"/>
          <p:nvPr/>
        </p:nvSpPr>
        <p:spPr>
          <a:xfrm>
            <a:off x="4576905" y="242471"/>
            <a:ext cx="3038191" cy="40011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Joint Range </a:t>
            </a:r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of Motio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C13E90A-0F51-4F06-993D-BF47F6FFD4FA}"/>
              </a:ext>
            </a:extLst>
          </p:cNvPr>
          <p:cNvSpPr/>
          <p:nvPr/>
        </p:nvSpPr>
        <p:spPr>
          <a:xfrm>
            <a:off x="423092" y="6451459"/>
            <a:ext cx="1134028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E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riance observed across targets in the kinematic variables of arm posture in the non-paretic and paretic arm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84D8E91-ADF3-46E1-9E68-072648889ED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0191" y="2817586"/>
            <a:ext cx="2439329" cy="18288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A22C771E-778A-4860-AEE8-30D602405AC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0190" y="964799"/>
            <a:ext cx="2439330" cy="182880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C2E265A3-BBF6-4809-ACE5-00C0B1C19570}"/>
              </a:ext>
            </a:extLst>
          </p:cNvPr>
          <p:cNvSpPr txBox="1"/>
          <p:nvPr/>
        </p:nvSpPr>
        <p:spPr>
          <a:xfrm>
            <a:off x="1258543" y="666513"/>
            <a:ext cx="1945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on-pareti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5639E3A-4370-4CF1-BBF4-2F82E42FA6B2}"/>
              </a:ext>
            </a:extLst>
          </p:cNvPr>
          <p:cNvSpPr txBox="1"/>
          <p:nvPr/>
        </p:nvSpPr>
        <p:spPr>
          <a:xfrm>
            <a:off x="4796041" y="666513"/>
            <a:ext cx="22621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e- Pareti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19DE010-FE54-47DB-840A-1F1E3C2837F4}"/>
              </a:ext>
            </a:extLst>
          </p:cNvPr>
          <p:cNvSpPr txBox="1"/>
          <p:nvPr/>
        </p:nvSpPr>
        <p:spPr>
          <a:xfrm>
            <a:off x="8406319" y="666513"/>
            <a:ext cx="23940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ost- Paretic</a:t>
            </a:r>
          </a:p>
        </p:txBody>
      </p:sp>
    </p:spTree>
    <p:extLst>
      <p:ext uri="{BB962C8B-B14F-4D97-AF65-F5344CB8AC3E}">
        <p14:creationId xmlns:p14="http://schemas.microsoft.com/office/powerpoint/2010/main" val="1519778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>
            <a:extLst>
              <a:ext uri="{FF2B5EF4-FFF2-40B4-BE49-F238E27FC236}">
                <a16:creationId xmlns:a16="http://schemas.microsoft.com/office/drawing/2014/main" id="{95F528D4-79F7-41A8-848A-E433C1AE87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9973" y="950723"/>
            <a:ext cx="3658994" cy="27432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966C609-8DE5-46AA-BF1B-E1E01F77BC8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7376" y="3670999"/>
            <a:ext cx="3658995" cy="27432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0313CF57-5C11-4E42-8A4A-D2F2002F54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3469" y="3724015"/>
            <a:ext cx="3658994" cy="27432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DE857D5-F37B-4CB9-ABAC-961F10CBA38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92" y="950723"/>
            <a:ext cx="3658994" cy="27432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D90500F-9138-4E88-9DA0-50CA9C865D3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92" y="3714530"/>
            <a:ext cx="3658994" cy="27432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BF481F8-BECD-40FB-9128-48DB4FA8CCD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5703" t="47433" r="50000"/>
          <a:stretch/>
        </p:blipFill>
        <p:spPr>
          <a:xfrm>
            <a:off x="7691280" y="3421412"/>
            <a:ext cx="523876" cy="312115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BE69164-3D02-4FA6-B16C-3DC24021D64C}"/>
              </a:ext>
            </a:extLst>
          </p:cNvPr>
          <p:cNvSpPr/>
          <p:nvPr/>
        </p:nvSpPr>
        <p:spPr>
          <a:xfrm>
            <a:off x="491318" y="445273"/>
            <a:ext cx="10957731" cy="5946002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FBF3ADB-D4DE-48CD-B37B-F77F793F0D32}"/>
              </a:ext>
            </a:extLst>
          </p:cNvPr>
          <p:cNvSpPr txBox="1"/>
          <p:nvPr/>
        </p:nvSpPr>
        <p:spPr>
          <a:xfrm>
            <a:off x="4576905" y="242471"/>
            <a:ext cx="3038191" cy="400110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runk Movement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3093363-2D24-476E-BC48-550E4FC51514}"/>
              </a:ext>
            </a:extLst>
          </p:cNvPr>
          <p:cNvSpPr txBox="1"/>
          <p:nvPr/>
        </p:nvSpPr>
        <p:spPr>
          <a:xfrm>
            <a:off x="4865324" y="638095"/>
            <a:ext cx="22621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e- Paretic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373D618-63C4-4474-A813-01B8FEB2BA19}"/>
              </a:ext>
            </a:extLst>
          </p:cNvPr>
          <p:cNvSpPr/>
          <p:nvPr/>
        </p:nvSpPr>
        <p:spPr>
          <a:xfrm>
            <a:off x="423092" y="6451459"/>
            <a:ext cx="1134028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D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riance observed across targets in the kinematic variables of trunk posture in the non-paretic and paretic arm.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50D6CAEC-F03F-4898-BEA8-CFBD59FD72C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7287" y="930116"/>
            <a:ext cx="3658994" cy="27432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E5EBCF8E-D63A-4CE8-A158-AD1AC39A590C}"/>
              </a:ext>
            </a:extLst>
          </p:cNvPr>
          <p:cNvSpPr txBox="1"/>
          <p:nvPr/>
        </p:nvSpPr>
        <p:spPr>
          <a:xfrm>
            <a:off x="1406883" y="634957"/>
            <a:ext cx="1945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on-pareti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49507DD-7597-4323-B1D0-858944000751}"/>
              </a:ext>
            </a:extLst>
          </p:cNvPr>
          <p:cNvSpPr txBox="1"/>
          <p:nvPr/>
        </p:nvSpPr>
        <p:spPr>
          <a:xfrm>
            <a:off x="8548064" y="642581"/>
            <a:ext cx="23940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ost- Paretic</a:t>
            </a:r>
          </a:p>
        </p:txBody>
      </p:sp>
    </p:spTree>
    <p:extLst>
      <p:ext uri="{BB962C8B-B14F-4D97-AF65-F5344CB8AC3E}">
        <p14:creationId xmlns:p14="http://schemas.microsoft.com/office/powerpoint/2010/main" val="1351646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169</TotalTime>
  <Words>144</Words>
  <Application>Microsoft Office PowerPoint</Application>
  <PresentationFormat>Widescreen</PresentationFormat>
  <Paragraphs>2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Supplementary Material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&amp; Tables</dc:title>
  <dc:creator>Adans-Dester, Catherine P.</dc:creator>
  <cp:lastModifiedBy>Adans-Dester, Catherine P.</cp:lastModifiedBy>
  <cp:revision>429</cp:revision>
  <cp:lastPrinted>2019-10-23T20:19:26Z</cp:lastPrinted>
  <dcterms:created xsi:type="dcterms:W3CDTF">2019-08-27T17:51:50Z</dcterms:created>
  <dcterms:modified xsi:type="dcterms:W3CDTF">2020-05-26T16:09:58Z</dcterms:modified>
</cp:coreProperties>
</file>